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246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A3BD0-5662-4544-9105-AA583ABFA009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F377-90EB-4F6F-A481-433D3F8BD8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853414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A3BD0-5662-4544-9105-AA583ABFA009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F377-90EB-4F6F-A481-433D3F8BD8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52112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A3BD0-5662-4544-9105-AA583ABFA009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F377-90EB-4F6F-A481-433D3F8BD8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90990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A3BD0-5662-4544-9105-AA583ABFA009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F377-90EB-4F6F-A481-433D3F8BD8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71191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A3BD0-5662-4544-9105-AA583ABFA009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F377-90EB-4F6F-A481-433D3F8BD8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23303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A3BD0-5662-4544-9105-AA583ABFA009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F377-90EB-4F6F-A481-433D3F8BD8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0045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A3BD0-5662-4544-9105-AA583ABFA009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F377-90EB-4F6F-A481-433D3F8BD8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42538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A3BD0-5662-4544-9105-AA583ABFA009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F377-90EB-4F6F-A481-433D3F8BD8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02766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A3BD0-5662-4544-9105-AA583ABFA009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F377-90EB-4F6F-A481-433D3F8BD8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24608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A3BD0-5662-4544-9105-AA583ABFA009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F377-90EB-4F6F-A481-433D3F8BD8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102540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A3BD0-5662-4544-9105-AA583ABFA009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F377-90EB-4F6F-A481-433D3F8BD8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519722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7A3BD0-5662-4544-9105-AA583ABFA009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ECF377-90EB-4F6F-A481-433D3F8BD89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50785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543430" y="1259135"/>
            <a:ext cx="5468693" cy="3846253"/>
            <a:chOff x="2551542" y="1594427"/>
            <a:chExt cx="5468693" cy="3846253"/>
          </a:xfrm>
        </p:grpSpPr>
        <p:grpSp>
          <p:nvGrpSpPr>
            <p:cNvPr id="5" name="Group 4"/>
            <p:cNvGrpSpPr/>
            <p:nvPr/>
          </p:nvGrpSpPr>
          <p:grpSpPr>
            <a:xfrm>
              <a:off x="2551542" y="1594427"/>
              <a:ext cx="5468693" cy="3845928"/>
              <a:chOff x="2551542" y="1594427"/>
              <a:chExt cx="5468693" cy="3845928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2551542" y="1594427"/>
                <a:ext cx="4367217" cy="3845928"/>
                <a:chOff x="2551542" y="1594427"/>
                <a:chExt cx="4367217" cy="3845928"/>
              </a:xfrm>
            </p:grpSpPr>
            <p:pic>
              <p:nvPicPr>
                <p:cNvPr id="12" name="Picture 7" descr="D:\Vivek\pET + ASR-1\PAGE gel photo\18.1.11.jpg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320" t="22757" r="19568" b="10917"/>
                <a:stretch/>
              </p:blipFill>
              <p:spPr bwMode="auto">
                <a:xfrm>
                  <a:off x="3822415" y="1844824"/>
                  <a:ext cx="3096344" cy="3595531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3" name="TextBox 12"/>
                <p:cNvSpPr txBox="1"/>
                <p:nvPr/>
              </p:nvSpPr>
              <p:spPr>
                <a:xfrm>
                  <a:off x="2647118" y="1844824"/>
                  <a:ext cx="578813" cy="342401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6.0</a:t>
                  </a:r>
                </a:p>
                <a:p>
                  <a:pPr algn="r"/>
                  <a:endParaRPr lang="en-US" sz="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sz="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r>
                    <a:rPr lang="en-US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8.0</a:t>
                  </a:r>
                </a:p>
                <a:p>
                  <a:pPr algn="r"/>
                  <a:endParaRPr lang="en-US" sz="75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sz="75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sz="75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r>
                    <a:rPr lang="en-US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5.0</a:t>
                  </a:r>
                </a:p>
                <a:p>
                  <a:pPr algn="r"/>
                  <a:endParaRPr lang="en-US" sz="5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sz="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r>
                    <a:rPr lang="en-US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.0</a:t>
                  </a:r>
                </a:p>
                <a:p>
                  <a:pPr algn="r"/>
                  <a:endPara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r>
                    <a:rPr lang="en-US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.0</a:t>
                  </a:r>
                </a:p>
                <a:p>
                  <a:pPr algn="r"/>
                  <a:endPara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r>
                    <a:rPr lang="en-US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8.0</a:t>
                  </a:r>
                </a:p>
                <a:p>
                  <a:pPr algn="r"/>
                  <a:endParaRPr 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r>
                    <a:rPr lang="en-US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4.4</a:t>
                  </a:r>
                  <a:endPara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2551542" y="1594427"/>
                  <a:ext cx="414728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</a:t>
                  </a:r>
                  <a:r>
                    <a:rPr lang="en-US" sz="14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r>
                    <a:rPr lang="en-US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  M           E1        E2        E3         E4        E5</a:t>
                  </a:r>
                  <a:endPara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8" name="Straight Arrow Connector 7"/>
              <p:cNvCxnSpPr/>
              <p:nvPr/>
            </p:nvCxnSpPr>
            <p:spPr>
              <a:xfrm flipH="1">
                <a:off x="6928386" y="3572454"/>
                <a:ext cx="360000" cy="0"/>
              </a:xfrm>
              <a:prstGeom prst="straightConnector1">
                <a:avLst/>
              </a:prstGeom>
              <a:ln w="38100">
                <a:solidFill>
                  <a:srgbClr val="00B0F0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TextBox 8"/>
              <p:cNvSpPr txBox="1"/>
              <p:nvPr/>
            </p:nvSpPr>
            <p:spPr>
              <a:xfrm>
                <a:off x="6981168" y="3341869"/>
                <a:ext cx="1039067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urified </a:t>
                </a:r>
              </a:p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H+</a:t>
                </a:r>
                <a:r>
                  <a:rPr lang="en-US" sz="12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b</a:t>
                </a:r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SR-1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6" name="Picture 2" descr="D:\Vivek\pET + ASR-1\PAGE gel photo\12.1.11.jpg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31" t="20809" r="87058" b="21377"/>
            <a:stretch/>
          </p:blipFill>
          <p:spPr bwMode="auto">
            <a:xfrm>
              <a:off x="3162157" y="1844824"/>
              <a:ext cx="628928" cy="35958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5" name="TextBox 14"/>
          <p:cNvSpPr txBox="1"/>
          <p:nvPr/>
        </p:nvSpPr>
        <p:spPr>
          <a:xfrm>
            <a:off x="1444279" y="5085184"/>
            <a:ext cx="543197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GB" sz="1400" b="1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rPr>
              <a:t>S5: </a:t>
            </a:r>
            <a:r>
              <a:rPr lang="en-GB" sz="1400" b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Purification of recombinant </a:t>
            </a:r>
            <a:r>
              <a:rPr lang="en-GB" sz="1400" b="1" i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Sb</a:t>
            </a:r>
            <a:r>
              <a:rPr lang="en-GB" sz="1400" b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ASR-1 protein from </a:t>
            </a:r>
            <a:r>
              <a:rPr lang="en-GB" sz="1400" b="1" i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E. coli </a:t>
            </a:r>
            <a:r>
              <a:rPr lang="en-GB" sz="1400" b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BL21 (DE3) cells. </a:t>
            </a:r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Lane 1 showed standard molecular marker of different size. Lane 2-6 have different fractions of elute (E1-E5). A light band of about 70 </a:t>
            </a:r>
            <a:r>
              <a:rPr lang="en-GB" sz="1400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 appears due to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presence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of a non-specific protein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fraction.</a:t>
            </a:r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GB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8726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72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VEKANAND</dc:creator>
  <cp:lastModifiedBy>Avinash Mishra</cp:lastModifiedBy>
  <cp:revision>9</cp:revision>
  <dcterms:created xsi:type="dcterms:W3CDTF">2014-08-26T17:00:30Z</dcterms:created>
  <dcterms:modified xsi:type="dcterms:W3CDTF">2015-04-27T06:19:53Z</dcterms:modified>
</cp:coreProperties>
</file>